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3" r:id="rId2"/>
  </p:sldIdLst>
  <p:sldSz cx="6858000" cy="9144000" type="screen4x3"/>
  <p:notesSz cx="9906000" cy="67691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5695" autoAdjust="0"/>
    <p:restoredTop sz="99656" autoAdjust="0"/>
  </p:normalViewPr>
  <p:slideViewPr>
    <p:cSldViewPr>
      <p:cViewPr>
        <p:scale>
          <a:sx n="200" d="100"/>
          <a:sy n="200" d="100"/>
        </p:scale>
        <p:origin x="-96" y="440"/>
      </p:cViewPr>
      <p:guideLst>
        <p:guide orient="horz" pos="567"/>
        <p:guide orient="horz" pos="3560"/>
        <p:guide orient="horz" pos="4468"/>
        <p:guide orient="horz" pos="3424"/>
        <p:guide orient="horz" pos="2125"/>
        <p:guide orient="horz" pos="1610"/>
        <p:guide orient="horz" pos="1020"/>
        <p:guide pos="845"/>
        <p:guide pos="3566"/>
        <p:guide pos="7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93220" cy="33845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5610458" y="0"/>
            <a:ext cx="4293220" cy="33845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BF5994-C9D9-4689-B94D-58E746417412}" type="datetimeFigureOut">
              <a:rPr lang="en-US" smtClean="0"/>
              <a:t>24.04.15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6429561"/>
            <a:ext cx="4293220" cy="3384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5610458" y="6429561"/>
            <a:ext cx="4293220" cy="3384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5D20D7-6D72-4D31-BADD-26A9DD3246B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4294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93220" cy="33845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5610458" y="0"/>
            <a:ext cx="4293220" cy="33845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929464-3C3B-4B29-ABBE-0D0CD7AE430E}" type="datetimeFigureOut">
              <a:rPr lang="en-US" smtClean="0"/>
              <a:t>24.04.15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000500" y="508000"/>
            <a:ext cx="1905000" cy="25384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989671" y="3215322"/>
            <a:ext cx="7926659" cy="304609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6429561"/>
            <a:ext cx="4293220" cy="3384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5610458" y="6429561"/>
            <a:ext cx="4293220" cy="3384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6E1500-B09D-4C21-B6DD-7E2A8F48CFE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7434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16632" y="107504"/>
            <a:ext cx="6624736" cy="504056"/>
          </a:xfrm>
        </p:spPr>
        <p:txBody>
          <a:bodyPr>
            <a:normAutofit/>
          </a:bodyPr>
          <a:lstStyle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DE" dirty="0" smtClean="0"/>
              <a:t>Titelmasterformat durch Klicken bearbeiten</a:t>
            </a:r>
            <a:endParaRPr lang="de-DE" dirty="0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24.04.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4183503"/>
              </p:ext>
            </p:extLst>
          </p:nvPr>
        </p:nvGraphicFramePr>
        <p:xfrm>
          <a:off x="548680" y="1043608"/>
          <a:ext cx="6085048" cy="3092949"/>
        </p:xfrm>
        <a:graphic>
          <a:graphicData uri="http://schemas.openxmlformats.org/drawingml/2006/table">
            <a:tbl>
              <a:tblPr/>
              <a:tblGrid>
                <a:gridCol w="623155"/>
                <a:gridCol w="419809"/>
                <a:gridCol w="419809"/>
                <a:gridCol w="419809"/>
                <a:gridCol w="218651"/>
                <a:gridCol w="623155"/>
                <a:gridCol w="419809"/>
                <a:gridCol w="419809"/>
                <a:gridCol w="419809"/>
                <a:gridCol w="218651"/>
                <a:gridCol w="623155"/>
                <a:gridCol w="419809"/>
                <a:gridCol w="419809"/>
                <a:gridCol w="419809"/>
              </a:tblGrid>
              <a:tr h="105916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H-E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N-5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LF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1183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         BI 2536</a:t>
                      </a:r>
                      <a:b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</a:b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VCR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5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         BI 2536</a:t>
                      </a:r>
                      <a:b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</a:b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VCR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         BI 2536</a:t>
                      </a:r>
                      <a:b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</a:b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VCR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59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5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03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02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91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28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75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81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17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31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44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59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4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83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21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91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77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64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21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42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94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59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.5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17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31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24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5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68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24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93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28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84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4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5916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5916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H-EP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N-5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1183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         BI 2536</a:t>
                      </a:r>
                      <a:b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</a:b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VBL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5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         BI 2536</a:t>
                      </a:r>
                      <a:b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</a:b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VBL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9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34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46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69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01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28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74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9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5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72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32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22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55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46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33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9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98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15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16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2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98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69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916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US" sz="7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916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H-EP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AN-5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1183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         BI 2536</a:t>
                      </a:r>
                      <a:b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</a:b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VNR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5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         BI 2536</a:t>
                      </a:r>
                      <a:b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</a:br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 VNR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 nM</a:t>
                      </a:r>
                    </a:p>
                  </a:txBody>
                  <a:tcPr marL="6230" marR="6230" marT="62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9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77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29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74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89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85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98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9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93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9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72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65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16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65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59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5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75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28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59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0 nM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16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79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51</a:t>
                      </a: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230" marR="6230" marT="623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7" name="Textfeld 6"/>
          <p:cNvSpPr txBox="1"/>
          <p:nvPr/>
        </p:nvSpPr>
        <p:spPr>
          <a:xfrm>
            <a:off x="5229200" y="466228"/>
            <a:ext cx="15781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. Tab. 1</a:t>
            </a:r>
            <a:endParaRPr lang="en-US" b="1" dirty="0"/>
          </a:p>
        </p:txBody>
      </p:sp>
      <p:sp>
        <p:nvSpPr>
          <p:cNvPr id="4" name="Textfeld 3"/>
          <p:cNvSpPr txBox="1"/>
          <p:nvPr/>
        </p:nvSpPr>
        <p:spPr>
          <a:xfrm>
            <a:off x="9348" y="190770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18305" y="31318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18257" y="72915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5570346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 Klassisch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5</Words>
  <Application>Microsoft Macintosh PowerPoint</Application>
  <PresentationFormat>Bildschirmpräsentation (4:3)</PresentationFormat>
  <Paragraphs>12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gulation of apoptosis in neuroblastoma  after inhibition of  Polo-like kinase 1</dc:title>
  <dc:creator>Sebastian Czaplinski</dc:creator>
  <cp:lastModifiedBy>Simone Fulda</cp:lastModifiedBy>
  <cp:revision>581</cp:revision>
  <cp:lastPrinted>2015-03-21T15:42:23Z</cp:lastPrinted>
  <dcterms:created xsi:type="dcterms:W3CDTF">2014-07-01T07:09:10Z</dcterms:created>
  <dcterms:modified xsi:type="dcterms:W3CDTF">2015-04-24T19:31:13Z</dcterms:modified>
</cp:coreProperties>
</file>